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88" r:id="rId2"/>
    <p:sldId id="284" r:id="rId3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051"/>
    <a:srgbClr val="009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C3C9268-BDC3-445B-865C-FAA38ABA6356}" v="2" dt="2023-09-19T17:04:40.1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38" autoAdjust="0"/>
    <p:restoredTop sz="80988"/>
  </p:normalViewPr>
  <p:slideViewPr>
    <p:cSldViewPr snapToGrid="0" snapToObjects="1" showGuides="1">
      <p:cViewPr varScale="1">
        <p:scale>
          <a:sx n="114" d="100"/>
          <a:sy n="114" d="100"/>
        </p:scale>
        <p:origin x="480" y="102"/>
      </p:cViewPr>
      <p:guideLst>
        <p:guide orient="horz" pos="4315"/>
        <p:guide pos="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raborty, Anirban" userId="beb374dd-c17a-4851-a293-48dd327a1c1a" providerId="ADAL" clId="{CC3C9268-BDC3-445B-865C-FAA38ABA6356}"/>
    <pc:docChg chg="delSld modSld">
      <pc:chgData name="Chakraborty, Anirban" userId="beb374dd-c17a-4851-a293-48dd327a1c1a" providerId="ADAL" clId="{CC3C9268-BDC3-445B-865C-FAA38ABA6356}" dt="2023-09-19T17:05:03.091" v="68" actId="1076"/>
      <pc:docMkLst>
        <pc:docMk/>
      </pc:docMkLst>
      <pc:sldChg chg="del">
        <pc:chgData name="Chakraborty, Anirban" userId="beb374dd-c17a-4851-a293-48dd327a1c1a" providerId="ADAL" clId="{CC3C9268-BDC3-445B-865C-FAA38ABA6356}" dt="2023-09-19T13:18:04.015" v="1" actId="47"/>
        <pc:sldMkLst>
          <pc:docMk/>
          <pc:sldMk cId="1499400212" sldId="270"/>
        </pc:sldMkLst>
      </pc:sldChg>
      <pc:sldChg chg="del">
        <pc:chgData name="Chakraborty, Anirban" userId="beb374dd-c17a-4851-a293-48dd327a1c1a" providerId="ADAL" clId="{CC3C9268-BDC3-445B-865C-FAA38ABA6356}" dt="2023-09-19T13:18:04.015" v="1" actId="47"/>
        <pc:sldMkLst>
          <pc:docMk/>
          <pc:sldMk cId="1362357393" sldId="271"/>
        </pc:sldMkLst>
      </pc:sldChg>
      <pc:sldChg chg="del">
        <pc:chgData name="Chakraborty, Anirban" userId="beb374dd-c17a-4851-a293-48dd327a1c1a" providerId="ADAL" clId="{CC3C9268-BDC3-445B-865C-FAA38ABA6356}" dt="2023-09-19T13:18:04.015" v="1" actId="47"/>
        <pc:sldMkLst>
          <pc:docMk/>
          <pc:sldMk cId="3109744734" sldId="272"/>
        </pc:sldMkLst>
      </pc:sldChg>
      <pc:sldChg chg="del">
        <pc:chgData name="Chakraborty, Anirban" userId="beb374dd-c17a-4851-a293-48dd327a1c1a" providerId="ADAL" clId="{CC3C9268-BDC3-445B-865C-FAA38ABA6356}" dt="2023-09-19T13:18:04.015" v="1" actId="47"/>
        <pc:sldMkLst>
          <pc:docMk/>
          <pc:sldMk cId="3096922174" sldId="274"/>
        </pc:sldMkLst>
      </pc:sldChg>
      <pc:sldChg chg="del">
        <pc:chgData name="Chakraborty, Anirban" userId="beb374dd-c17a-4851-a293-48dd327a1c1a" providerId="ADAL" clId="{CC3C9268-BDC3-445B-865C-FAA38ABA6356}" dt="2023-09-19T13:18:04.015" v="1" actId="47"/>
        <pc:sldMkLst>
          <pc:docMk/>
          <pc:sldMk cId="2573754816" sldId="276"/>
        </pc:sldMkLst>
      </pc:sldChg>
      <pc:sldChg chg="del">
        <pc:chgData name="Chakraborty, Anirban" userId="beb374dd-c17a-4851-a293-48dd327a1c1a" providerId="ADAL" clId="{CC3C9268-BDC3-445B-865C-FAA38ABA6356}" dt="2023-09-19T13:17:58.909" v="0" actId="47"/>
        <pc:sldMkLst>
          <pc:docMk/>
          <pc:sldMk cId="550479794" sldId="278"/>
        </pc:sldMkLst>
      </pc:sldChg>
      <pc:sldChg chg="del">
        <pc:chgData name="Chakraborty, Anirban" userId="beb374dd-c17a-4851-a293-48dd327a1c1a" providerId="ADAL" clId="{CC3C9268-BDC3-445B-865C-FAA38ABA6356}" dt="2023-09-19T13:18:04.015" v="1" actId="47"/>
        <pc:sldMkLst>
          <pc:docMk/>
          <pc:sldMk cId="3002076954" sldId="279"/>
        </pc:sldMkLst>
      </pc:sldChg>
      <pc:sldChg chg="del">
        <pc:chgData name="Chakraborty, Anirban" userId="beb374dd-c17a-4851-a293-48dd327a1c1a" providerId="ADAL" clId="{CC3C9268-BDC3-445B-865C-FAA38ABA6356}" dt="2023-09-19T13:18:09.930" v="2" actId="47"/>
        <pc:sldMkLst>
          <pc:docMk/>
          <pc:sldMk cId="3852428335" sldId="280"/>
        </pc:sldMkLst>
      </pc:sldChg>
      <pc:sldChg chg="del">
        <pc:chgData name="Chakraborty, Anirban" userId="beb374dd-c17a-4851-a293-48dd327a1c1a" providerId="ADAL" clId="{CC3C9268-BDC3-445B-865C-FAA38ABA6356}" dt="2023-09-19T13:18:09.930" v="2" actId="47"/>
        <pc:sldMkLst>
          <pc:docMk/>
          <pc:sldMk cId="1026364918" sldId="281"/>
        </pc:sldMkLst>
      </pc:sldChg>
      <pc:sldChg chg="del">
        <pc:chgData name="Chakraborty, Anirban" userId="beb374dd-c17a-4851-a293-48dd327a1c1a" providerId="ADAL" clId="{CC3C9268-BDC3-445B-865C-FAA38ABA6356}" dt="2023-09-19T13:18:09.930" v="2" actId="47"/>
        <pc:sldMkLst>
          <pc:docMk/>
          <pc:sldMk cId="2329365240" sldId="282"/>
        </pc:sldMkLst>
      </pc:sldChg>
      <pc:sldChg chg="addSp modSp mod">
        <pc:chgData name="Chakraborty, Anirban" userId="beb374dd-c17a-4851-a293-48dd327a1c1a" providerId="ADAL" clId="{CC3C9268-BDC3-445B-865C-FAA38ABA6356}" dt="2023-09-19T17:05:03.091" v="68" actId="1076"/>
        <pc:sldMkLst>
          <pc:docMk/>
          <pc:sldMk cId="438658365" sldId="284"/>
        </pc:sldMkLst>
        <pc:spChg chg="add mod">
          <ac:chgData name="Chakraborty, Anirban" userId="beb374dd-c17a-4851-a293-48dd327a1c1a" providerId="ADAL" clId="{CC3C9268-BDC3-445B-865C-FAA38ABA6356}" dt="2023-09-19T17:04:36.123" v="57" actId="1076"/>
          <ac:spMkLst>
            <pc:docMk/>
            <pc:sldMk cId="438658365" sldId="284"/>
            <ac:spMk id="6" creationId="{8FEF8457-1148-56CB-6AF4-DD2FE0520C4F}"/>
          </ac:spMkLst>
        </pc:spChg>
        <pc:spChg chg="add mod">
          <ac:chgData name="Chakraborty, Anirban" userId="beb374dd-c17a-4851-a293-48dd327a1c1a" providerId="ADAL" clId="{CC3C9268-BDC3-445B-865C-FAA38ABA6356}" dt="2023-09-19T17:04:57.099" v="67" actId="1076"/>
          <ac:spMkLst>
            <pc:docMk/>
            <pc:sldMk cId="438658365" sldId="284"/>
            <ac:spMk id="7" creationId="{C882C055-A642-8D19-A741-BD23A35BBF55}"/>
          </ac:spMkLst>
        </pc:spChg>
        <pc:spChg chg="mod">
          <ac:chgData name="Chakraborty, Anirban" userId="beb374dd-c17a-4851-a293-48dd327a1c1a" providerId="ADAL" clId="{CC3C9268-BDC3-445B-865C-FAA38ABA6356}" dt="2023-09-19T13:47:22.450" v="25" actId="1037"/>
          <ac:spMkLst>
            <pc:docMk/>
            <pc:sldMk cId="438658365" sldId="284"/>
            <ac:spMk id="21" creationId="{00000000-0000-0000-0000-000000000000}"/>
          </ac:spMkLst>
        </pc:spChg>
        <pc:spChg chg="mod">
          <ac:chgData name="Chakraborty, Anirban" userId="beb374dd-c17a-4851-a293-48dd327a1c1a" providerId="ADAL" clId="{CC3C9268-BDC3-445B-865C-FAA38ABA6356}" dt="2023-09-19T17:05:03.091" v="68" actId="1076"/>
          <ac:spMkLst>
            <pc:docMk/>
            <pc:sldMk cId="438658365" sldId="284"/>
            <ac:spMk id="28" creationId="{00000000-0000-0000-0000-000000000000}"/>
          </ac:spMkLst>
        </pc:spChg>
        <pc:cxnChg chg="mod">
          <ac:chgData name="Chakraborty, Anirban" userId="beb374dd-c17a-4851-a293-48dd327a1c1a" providerId="ADAL" clId="{CC3C9268-BDC3-445B-865C-FAA38ABA6356}" dt="2023-09-19T13:48:38.169" v="31" actId="1037"/>
          <ac:cxnSpMkLst>
            <pc:docMk/>
            <pc:sldMk cId="438658365" sldId="284"/>
            <ac:cxnSpMk id="3" creationId="{00000000-0000-0000-0000-000000000000}"/>
          </ac:cxnSpMkLst>
        </pc:cxnChg>
        <pc:cxnChg chg="mod">
          <ac:chgData name="Chakraborty, Anirban" userId="beb374dd-c17a-4851-a293-48dd327a1c1a" providerId="ADAL" clId="{CC3C9268-BDC3-445B-865C-FAA38ABA6356}" dt="2023-09-19T13:48:33.562" v="29" actId="1038"/>
          <ac:cxnSpMkLst>
            <pc:docMk/>
            <pc:sldMk cId="438658365" sldId="284"/>
            <ac:cxnSpMk id="27" creationId="{00000000-0000-0000-0000-000000000000}"/>
          </ac:cxnSpMkLst>
        </pc:cxnChg>
      </pc:sldChg>
      <pc:sldChg chg="del">
        <pc:chgData name="Chakraborty, Anirban" userId="beb374dd-c17a-4851-a293-48dd327a1c1a" providerId="ADAL" clId="{CC3C9268-BDC3-445B-865C-FAA38ABA6356}" dt="2023-09-19T13:18:09.930" v="2" actId="47"/>
        <pc:sldMkLst>
          <pc:docMk/>
          <pc:sldMk cId="1305156795" sldId="285"/>
        </pc:sldMkLst>
      </pc:sldChg>
      <pc:sldChg chg="del">
        <pc:chgData name="Chakraborty, Anirban" userId="beb374dd-c17a-4851-a293-48dd327a1c1a" providerId="ADAL" clId="{CC3C9268-BDC3-445B-865C-FAA38ABA6356}" dt="2023-09-19T13:18:09.930" v="2" actId="47"/>
        <pc:sldMkLst>
          <pc:docMk/>
          <pc:sldMk cId="4028044274" sldId="286"/>
        </pc:sldMkLst>
      </pc:sldChg>
      <pc:sldChg chg="del">
        <pc:chgData name="Chakraborty, Anirban" userId="beb374dd-c17a-4851-a293-48dd327a1c1a" providerId="ADAL" clId="{CC3C9268-BDC3-445B-865C-FAA38ABA6356}" dt="2023-09-19T13:18:09.930" v="2" actId="47"/>
        <pc:sldMkLst>
          <pc:docMk/>
          <pc:sldMk cId="256142667" sldId="28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E8D3B8AE-E6A7-C943-834B-509E182B2575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32450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2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F048A57D-F6E1-034D-9BC0-9C2FC71C8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227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2D4F7-2021-A642-B0CE-338B12301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CCA26C-5B50-B94F-82D6-8760696C27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86B55-454B-624D-A8D3-B1248D1B5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245B3-23F0-9445-AE77-CA1A1FD8D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6163F-C787-3142-915E-C39148617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278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E13B3-C6AC-5A43-9ACB-B4BA394C2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46718-2042-F04B-9FAD-3A485529EF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14F6B8-0A0A-AE4D-A494-4C95AE6C0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5348F-7B1A-4B46-B822-6736B2938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3BCF7-4449-3A4E-B494-1AFC21D8A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18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7DFC63B-84F7-4243-A5B4-1EC304FD4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4AB81E-D3C6-C94C-A282-3BF98AFCD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F9AD0D-7288-654F-956C-AD2593D6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14BA3-1568-7241-BDAB-8CA5920E1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64E63-C144-C745-A366-8399D4020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81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4461C-9762-2342-A51E-38E476E7C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24E9A-EA4E-1744-AF11-1D43DC789A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C2680-0E9C-3144-862B-AFB3E69D4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A7B78-FC12-D747-AAC1-F9FAD2ADC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8D220A-A23D-CA41-995A-E6A03A04E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9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078E1-7996-144E-B8D4-476A68562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0D34C9-D05D-1E49-84C5-6333390D5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06A32-BAB0-E645-8BDF-589DD81C4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ABB79-D302-C944-A688-1B470D9DF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1689D-4A8C-8E46-82E9-B3534632D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90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BDA4-9FCB-EE4C-810C-5C5661A10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51E0D0-4ABC-714F-89BF-8FCDBAE746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2CB25A-C5E7-D94D-B661-81D2A868C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377595-6DF1-794D-A232-1C9958EDD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39CD3-9B4C-504C-879A-B4107E76E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AA483B-07C6-2043-8671-5B808FCA0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072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0A434-9C06-A042-A4F7-732F43984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32AE10-BF72-0049-A0E4-F4BA1C9927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8F7D1D-D036-B44B-9630-10A6978CF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2EEC0-124E-EC46-8D02-E81AD515A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E4BCE2-4DE2-D24C-86A9-F1C6DF7249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C13A7F2-94A9-B349-9B3B-D0F826A3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CC8104-22AE-3045-9A1A-2FA341AFA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E858AB-36F4-684B-A9FE-18BB4BC0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5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DAA0F-1B23-4344-A407-89B3D606D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1CE5D9-E60A-9F46-8E26-6AB7D339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FD3E93-5CF8-F348-A2F5-35068A6A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692F73-EA23-F34A-B504-CD619EC2C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9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F41EA2-0F06-6444-967C-B8D532FB3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0B9B18-2F70-1048-BBA6-F718B5702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47B7B-3038-7141-BB16-7C04389F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67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1EAD8-56A1-5E41-B7CA-A0A401B02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040C8-CB84-0B4E-88B3-B0C73BBC46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22BAF-B99A-4E49-A59A-614A49394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12B9D-5CAD-3A41-8FBA-DC8923E9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1579BE-E6ED-F945-ABE3-80AAC0A4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ED946-F4A8-C24C-A6DA-BD2627D6F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944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022CB-3D02-1B4F-841E-DE018BDD6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453081-0A59-1244-B45A-AA0D2D67F6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4762F7-554D-E34C-A3DD-AE030B3D4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6D7CA-F115-1B41-8DF9-AC61BF628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61EFA-B3A1-C442-89E4-0AE92344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531CB6-9230-FB4A-84ED-FD6D385D0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780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AF5F41-1579-A24F-A466-EE012090C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AB8E2-733C-0C44-8972-CE6D7845E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5B314-1FC4-DC40-8D1B-57D2252FED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94233-00F9-CD40-A979-E1470974676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DC9C2-2FD4-D142-8295-6FFB674C28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99995-9E3D-E54E-A29C-ECE6B5776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4C89B-915B-C84A-94A4-1AA4B284A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662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362201" y="1838325"/>
            <a:ext cx="7781924" cy="2476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195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70" name="Group 9"/>
          <p:cNvGrpSpPr>
            <a:grpSpLocks/>
          </p:cNvGrpSpPr>
          <p:nvPr/>
        </p:nvGrpSpPr>
        <p:grpSpPr bwMode="auto">
          <a:xfrm>
            <a:off x="8216900" y="219077"/>
            <a:ext cx="2693988" cy="4752976"/>
            <a:chOff x="3200400" y="93367"/>
            <a:chExt cx="2981325" cy="5326358"/>
          </a:xfrm>
        </p:grpSpPr>
        <p:pic>
          <p:nvPicPr>
            <p:cNvPr id="7177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00400" y="2971800"/>
              <a:ext cx="2981325" cy="24479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178" name="TextBox 10"/>
            <p:cNvSpPr txBox="1">
              <a:spLocks noChangeArrowheads="1"/>
            </p:cNvSpPr>
            <p:nvPr/>
          </p:nvSpPr>
          <p:spPr bwMode="auto">
            <a:xfrm rot="16200000">
              <a:off x="2800154" y="1731798"/>
              <a:ext cx="1676209" cy="306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panose="020B0604020202020204" pitchFamily="34" charset="0"/>
                </a:rPr>
                <a:t>Substrate alone</a:t>
              </a:r>
            </a:p>
          </p:txBody>
        </p:sp>
        <p:sp>
          <p:nvSpPr>
            <p:cNvPr id="7179" name="TextBox 11"/>
            <p:cNvSpPr txBox="1">
              <a:spLocks noChangeArrowheads="1"/>
            </p:cNvSpPr>
            <p:nvPr/>
          </p:nvSpPr>
          <p:spPr bwMode="auto">
            <a:xfrm rot="16200000">
              <a:off x="3232245" y="1766616"/>
              <a:ext cx="1676209" cy="306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panose="020B0604020202020204" pitchFamily="34" charset="0"/>
                </a:rPr>
                <a:t>5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ligase</a:t>
              </a:r>
            </a:p>
          </p:txBody>
        </p:sp>
        <p:sp>
          <p:nvSpPr>
            <p:cNvPr id="7180" name="TextBox 12"/>
            <p:cNvSpPr txBox="1">
              <a:spLocks noChangeArrowheads="1"/>
            </p:cNvSpPr>
            <p:nvPr/>
          </p:nvSpPr>
          <p:spPr bwMode="auto">
            <a:xfrm rot="16200000">
              <a:off x="3147181" y="1314588"/>
              <a:ext cx="2580268" cy="306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panose="020B0604020202020204" pitchFamily="34" charset="0"/>
                </a:rPr>
                <a:t>5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ligase + 5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Q29</a:t>
              </a:r>
            </a:p>
          </p:txBody>
        </p:sp>
        <p:sp>
          <p:nvSpPr>
            <p:cNvPr id="7181" name="TextBox 13"/>
            <p:cNvSpPr txBox="1">
              <a:spLocks noChangeArrowheads="1"/>
            </p:cNvSpPr>
            <p:nvPr/>
          </p:nvSpPr>
          <p:spPr bwMode="auto">
            <a:xfrm rot="16200000">
              <a:off x="3484515" y="1322641"/>
              <a:ext cx="2573917" cy="306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panose="020B0604020202020204" pitchFamily="34" charset="0"/>
                </a:rPr>
                <a:t>5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ligase + 10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Q29</a:t>
              </a:r>
            </a:p>
          </p:txBody>
        </p:sp>
        <p:sp>
          <p:nvSpPr>
            <p:cNvPr id="7182" name="TextBox 14"/>
            <p:cNvSpPr txBox="1">
              <a:spLocks noChangeArrowheads="1"/>
            </p:cNvSpPr>
            <p:nvPr/>
          </p:nvSpPr>
          <p:spPr bwMode="auto">
            <a:xfrm rot="16200000">
              <a:off x="3776900" y="1274817"/>
              <a:ext cx="2669443" cy="306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panose="020B0604020202020204" pitchFamily="34" charset="0"/>
                </a:rPr>
                <a:t>5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ligase +5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Q72</a:t>
              </a:r>
            </a:p>
          </p:txBody>
        </p:sp>
        <p:sp>
          <p:nvSpPr>
            <p:cNvPr id="7183" name="TextBox 15"/>
            <p:cNvSpPr txBox="1">
              <a:spLocks noChangeArrowheads="1"/>
            </p:cNvSpPr>
            <p:nvPr/>
          </p:nvSpPr>
          <p:spPr bwMode="auto">
            <a:xfrm rot="16200000">
              <a:off x="4261249" y="1360410"/>
              <a:ext cx="2454650" cy="306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>
                  <a:latin typeface="Arial" panose="020B0604020202020204" pitchFamily="34" charset="0"/>
                </a:rPr>
                <a:t>5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ligase +100 </a:t>
              </a:r>
              <a:r>
                <a:rPr lang="en-US" altLang="en-US" sz="1200" dirty="0" err="1">
                  <a:latin typeface="Arial" panose="020B0604020202020204" pitchFamily="34" charset="0"/>
                </a:rPr>
                <a:t>fmol</a:t>
              </a:r>
              <a:r>
                <a:rPr lang="en-US" altLang="en-US" sz="1200" dirty="0">
                  <a:latin typeface="Arial" panose="020B0604020202020204" pitchFamily="34" charset="0"/>
                </a:rPr>
                <a:t> Q72</a:t>
              </a:r>
            </a:p>
          </p:txBody>
        </p:sp>
      </p:grpSp>
      <p:sp>
        <p:nvSpPr>
          <p:cNvPr id="7171" name="TextBox 15"/>
          <p:cNvSpPr txBox="1">
            <a:spLocks noChangeArrowheads="1"/>
          </p:cNvSpPr>
          <p:nvPr/>
        </p:nvSpPr>
        <p:spPr bwMode="auto">
          <a:xfrm>
            <a:off x="6537325" y="3117997"/>
            <a:ext cx="17684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" panose="020B0604020202020204" pitchFamily="34" charset="0"/>
              </a:rPr>
              <a:t>51 </a:t>
            </a:r>
            <a:r>
              <a:rPr lang="en-US" altLang="en-US" sz="1200" dirty="0" err="1">
                <a:latin typeface="Arial" panose="020B0604020202020204" pitchFamily="34" charset="0"/>
              </a:rPr>
              <a:t>mer</a:t>
            </a:r>
            <a:r>
              <a:rPr lang="en-US" altLang="en-US" sz="1200" dirty="0">
                <a:latin typeface="Arial" panose="020B0604020202020204" pitchFamily="34" charset="0"/>
              </a:rPr>
              <a:t> ligated product</a:t>
            </a:r>
          </a:p>
        </p:txBody>
      </p:sp>
      <p:sp>
        <p:nvSpPr>
          <p:cNvPr id="7172" name="TextBox 16"/>
          <p:cNvSpPr txBox="1">
            <a:spLocks noChangeArrowheads="1"/>
          </p:cNvSpPr>
          <p:nvPr/>
        </p:nvSpPr>
        <p:spPr bwMode="auto">
          <a:xfrm>
            <a:off x="6391275" y="3592513"/>
            <a:ext cx="191452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dirty="0">
                <a:latin typeface="Arial" panose="020B0604020202020204" pitchFamily="34" charset="0"/>
              </a:rPr>
              <a:t>26 </a:t>
            </a:r>
            <a:r>
              <a:rPr lang="en-US" altLang="en-US" sz="1200" dirty="0" err="1">
                <a:latin typeface="Arial" panose="020B0604020202020204" pitchFamily="34" charset="0"/>
              </a:rPr>
              <a:t>mer</a:t>
            </a:r>
            <a:r>
              <a:rPr lang="en-US" altLang="en-US" sz="1200" dirty="0">
                <a:latin typeface="Arial" panose="020B0604020202020204" pitchFamily="34" charset="0"/>
              </a:rPr>
              <a:t> </a:t>
            </a:r>
            <a:r>
              <a:rPr lang="en-US" altLang="en-US" sz="1200" dirty="0" err="1">
                <a:latin typeface="Arial" panose="020B0604020202020204" pitchFamily="34" charset="0"/>
              </a:rPr>
              <a:t>unligated</a:t>
            </a:r>
            <a:r>
              <a:rPr lang="en-US" altLang="en-US" sz="1200" dirty="0">
                <a:latin typeface="Arial" panose="020B0604020202020204" pitchFamily="34" charset="0"/>
              </a:rPr>
              <a:t> 32P labeled substrate</a:t>
            </a:r>
          </a:p>
        </p:txBody>
      </p:sp>
      <p:sp>
        <p:nvSpPr>
          <p:cNvPr id="7175" name="Text Box 8"/>
          <p:cNvSpPr txBox="1">
            <a:spLocks noChangeArrowheads="1"/>
          </p:cNvSpPr>
          <p:nvPr/>
        </p:nvSpPr>
        <p:spPr bwMode="auto">
          <a:xfrm>
            <a:off x="1330325" y="1879601"/>
            <a:ext cx="32004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en-US" sz="900" dirty="0">
                <a:latin typeface="Arial" panose="020B0604020202020204" pitchFamily="34" charset="0"/>
              </a:rPr>
              <a:t>             1                    2           3          4           5            6   </a:t>
            </a:r>
          </a:p>
        </p:txBody>
      </p:sp>
      <p:sp>
        <p:nvSpPr>
          <p:cNvPr id="7176" name="Text Box 7"/>
          <p:cNvSpPr txBox="1">
            <a:spLocks noChangeArrowheads="1"/>
          </p:cNvSpPr>
          <p:nvPr/>
        </p:nvSpPr>
        <p:spPr bwMode="auto">
          <a:xfrm>
            <a:off x="1350963" y="4441826"/>
            <a:ext cx="4202112" cy="19389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marL="342900" indent="-34290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en-US" sz="1200" dirty="0">
                <a:latin typeface="Arial" panose="020B0604020202020204" pitchFamily="34" charset="0"/>
              </a:rPr>
              <a:t>1       Pol</a:t>
            </a:r>
            <a:r>
              <a:rPr lang="el-GR" altLang="en-US" sz="1200" dirty="0">
                <a:latin typeface="Arial" panose="020B0604020202020204" pitchFamily="34" charset="0"/>
              </a:rPr>
              <a:t>β</a:t>
            </a:r>
            <a:r>
              <a:rPr lang="en-US" altLang="en-US" sz="1200" dirty="0">
                <a:latin typeface="Arial" panose="020B0604020202020204" pitchFamily="34" charset="0"/>
              </a:rPr>
              <a:t> only 5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endParaRPr lang="en-US" altLang="en-US" sz="1200" dirty="0">
              <a:latin typeface="Arial" panose="020B0604020202020204" pitchFamily="34" charset="0"/>
            </a:endParaRPr>
          </a:p>
          <a:p>
            <a:pPr eaLnBrk="1" hangingPunct="1">
              <a:spcBef>
                <a:spcPct val="50000"/>
              </a:spcBef>
              <a:buFontTx/>
              <a:buAutoNum type="arabicPlain" startAt="2"/>
            </a:pPr>
            <a:r>
              <a:rPr lang="en-US" altLang="en-US" sz="1200" dirty="0">
                <a:latin typeface="Arial" panose="020B0604020202020204" pitchFamily="34" charset="0"/>
              </a:rPr>
              <a:t>Substrate without pol </a:t>
            </a:r>
            <a:r>
              <a:rPr lang="el-GR" altLang="en-US" sz="1200" dirty="0">
                <a:latin typeface="Arial" panose="020B0604020202020204" pitchFamily="34" charset="0"/>
              </a:rPr>
              <a:t>β</a:t>
            </a:r>
            <a:r>
              <a:rPr lang="en-US" altLang="en-US" sz="1200" dirty="0">
                <a:latin typeface="Arial" panose="020B0604020202020204" pitchFamily="34" charset="0"/>
              </a:rPr>
              <a:t>.</a:t>
            </a:r>
          </a:p>
          <a:p>
            <a:pPr eaLnBrk="1" hangingPunct="1">
              <a:spcBef>
                <a:spcPct val="50000"/>
              </a:spcBef>
              <a:buFontTx/>
              <a:buAutoNum type="arabicPlain" startAt="2"/>
            </a:pPr>
            <a:r>
              <a:rPr lang="en-US" altLang="en-US" sz="1200" dirty="0">
                <a:latin typeface="Arial" panose="020B0604020202020204" pitchFamily="34" charset="0"/>
              </a:rPr>
              <a:t>Substrate + 5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pol</a:t>
            </a:r>
            <a:r>
              <a:rPr lang="el-GR" altLang="en-US" sz="1200" dirty="0">
                <a:latin typeface="Arial" panose="020B0604020202020204" pitchFamily="34" charset="0"/>
              </a:rPr>
              <a:t>β</a:t>
            </a:r>
            <a:r>
              <a:rPr lang="en-US" altLang="en-US" sz="1200" dirty="0">
                <a:latin typeface="Arial" panose="020B0604020202020204" pitchFamily="34" charset="0"/>
              </a:rPr>
              <a:t> + 5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Q72</a:t>
            </a:r>
          </a:p>
          <a:p>
            <a:pPr eaLnBrk="1" hangingPunct="1">
              <a:spcBef>
                <a:spcPct val="50000"/>
              </a:spcBef>
              <a:buFontTx/>
              <a:buAutoNum type="arabicPlain" startAt="2"/>
            </a:pPr>
            <a:r>
              <a:rPr lang="en-US" altLang="en-US" sz="1200">
                <a:latin typeface="Arial" panose="020B0604020202020204" pitchFamily="34" charset="0"/>
              </a:rPr>
              <a:t>Substrate + 5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pol</a:t>
            </a:r>
            <a:r>
              <a:rPr lang="el-GR" altLang="en-US" sz="1200" dirty="0">
                <a:latin typeface="Arial" panose="020B0604020202020204" pitchFamily="34" charset="0"/>
              </a:rPr>
              <a:t>β</a:t>
            </a:r>
            <a:r>
              <a:rPr lang="en-US" altLang="en-US" sz="1200" dirty="0">
                <a:latin typeface="Arial" panose="020B0604020202020204" pitchFamily="34" charset="0"/>
              </a:rPr>
              <a:t> + 10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Q72</a:t>
            </a:r>
          </a:p>
          <a:p>
            <a:pPr eaLnBrk="1" hangingPunct="1">
              <a:spcBef>
                <a:spcPct val="50000"/>
              </a:spcBef>
              <a:buFontTx/>
              <a:buAutoNum type="arabicPlain" startAt="2"/>
            </a:pPr>
            <a:r>
              <a:rPr lang="en-US" altLang="en-US" sz="1200" dirty="0">
                <a:latin typeface="Arial" panose="020B0604020202020204" pitchFamily="34" charset="0"/>
              </a:rPr>
              <a:t>Substrate + 5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pol</a:t>
            </a:r>
            <a:r>
              <a:rPr lang="el-GR" altLang="en-US" sz="1200" dirty="0">
                <a:latin typeface="Arial" panose="020B0604020202020204" pitchFamily="34" charset="0"/>
              </a:rPr>
              <a:t>β</a:t>
            </a:r>
            <a:r>
              <a:rPr lang="en-US" altLang="en-US" sz="1200" dirty="0">
                <a:latin typeface="Arial" panose="020B0604020202020204" pitchFamily="34" charset="0"/>
              </a:rPr>
              <a:t> + 5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Q29</a:t>
            </a:r>
          </a:p>
          <a:p>
            <a:pPr eaLnBrk="1" hangingPunct="1">
              <a:spcBef>
                <a:spcPct val="50000"/>
              </a:spcBef>
              <a:buFontTx/>
              <a:buAutoNum type="arabicPlain" startAt="2"/>
            </a:pPr>
            <a:r>
              <a:rPr lang="en-US" altLang="en-US" sz="1200" dirty="0">
                <a:latin typeface="Arial" panose="020B0604020202020204" pitchFamily="34" charset="0"/>
              </a:rPr>
              <a:t>Substrate + 5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pol</a:t>
            </a:r>
            <a:r>
              <a:rPr lang="el-GR" altLang="en-US" sz="1200" dirty="0">
                <a:latin typeface="Arial" panose="020B0604020202020204" pitchFamily="34" charset="0"/>
              </a:rPr>
              <a:t>β</a:t>
            </a:r>
            <a:r>
              <a:rPr lang="en-US" altLang="en-US" sz="1200" dirty="0">
                <a:latin typeface="Arial" panose="020B0604020202020204" pitchFamily="34" charset="0"/>
              </a:rPr>
              <a:t> + 100 </a:t>
            </a:r>
            <a:r>
              <a:rPr lang="en-US" altLang="en-US" sz="1200" dirty="0" err="1">
                <a:latin typeface="Arial" panose="020B0604020202020204" pitchFamily="34" charset="0"/>
              </a:rPr>
              <a:t>fmol</a:t>
            </a:r>
            <a:r>
              <a:rPr lang="en-US" altLang="en-US" sz="1200" dirty="0">
                <a:latin typeface="Arial" panose="020B0604020202020204" pitchFamily="34" charset="0"/>
              </a:rPr>
              <a:t> Q29</a:t>
            </a:r>
          </a:p>
          <a:p>
            <a:pPr eaLnBrk="1" hangingPunct="1">
              <a:spcBef>
                <a:spcPct val="50000"/>
              </a:spcBef>
              <a:buFontTx/>
              <a:buAutoNum type="arabicPlain" startAt="2"/>
            </a:pPr>
            <a:r>
              <a:rPr lang="en-US" altLang="en-US" sz="1200" dirty="0">
                <a:latin typeface="Arial" panose="020B0604020202020204" pitchFamily="34" charset="0"/>
              </a:rPr>
              <a:t>25 </a:t>
            </a:r>
            <a:r>
              <a:rPr lang="en-US" altLang="en-US" sz="1200" dirty="0" err="1">
                <a:latin typeface="Arial" panose="020B0604020202020204" pitchFamily="34" charset="0"/>
              </a:rPr>
              <a:t>nt</a:t>
            </a:r>
            <a:r>
              <a:rPr lang="en-US" altLang="en-US" sz="1200" dirty="0">
                <a:latin typeface="Arial" panose="020B0604020202020204" pitchFamily="34" charset="0"/>
              </a:rPr>
              <a:t> labeled molecular marker.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848225" y="72490"/>
            <a:ext cx="30483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iginal uncropped Fig. S6</a:t>
            </a:r>
          </a:p>
        </p:txBody>
      </p:sp>
      <p:sp>
        <p:nvSpPr>
          <p:cNvPr id="19" name="Text Box 8"/>
          <p:cNvSpPr txBox="1">
            <a:spLocks noChangeArrowheads="1"/>
          </p:cNvSpPr>
          <p:nvPr/>
        </p:nvSpPr>
        <p:spPr bwMode="auto">
          <a:xfrm>
            <a:off x="8084312" y="2565784"/>
            <a:ext cx="32004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en-US" sz="900" dirty="0">
                <a:latin typeface="Arial" panose="020B0604020202020204" pitchFamily="34" charset="0"/>
              </a:rPr>
              <a:t>             1           2       3        4        5        6</a:t>
            </a:r>
          </a:p>
        </p:txBody>
      </p:sp>
      <p:sp>
        <p:nvSpPr>
          <p:cNvPr id="20" name="Rectangle 19"/>
          <p:cNvSpPr/>
          <p:nvPr/>
        </p:nvSpPr>
        <p:spPr>
          <a:xfrm>
            <a:off x="8474060" y="2983998"/>
            <a:ext cx="2070116" cy="9604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9712485" y="2688401"/>
            <a:ext cx="1081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H="1">
            <a:off x="10927666" y="3117997"/>
            <a:ext cx="3738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H="1">
            <a:off x="10925394" y="3670447"/>
            <a:ext cx="3738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11267727" y="2840870"/>
            <a:ext cx="800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igated product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1258550" y="3487328"/>
            <a:ext cx="933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bstrat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7516" y="2111375"/>
            <a:ext cx="3420209" cy="2012789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1548588" y="2688401"/>
            <a:ext cx="2982137" cy="11914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3148024" y="2378042"/>
            <a:ext cx="1069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oppe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64175" y="931157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062217" y="713064"/>
            <a:ext cx="41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5" name="Rectangle 4"/>
          <p:cNvSpPr/>
          <p:nvPr/>
        </p:nvSpPr>
        <p:spPr>
          <a:xfrm>
            <a:off x="1237515" y="2111376"/>
            <a:ext cx="3420209" cy="20127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EF8457-1148-56CB-6AF4-DD2FE0520C4F}"/>
              </a:ext>
            </a:extLst>
          </p:cNvPr>
          <p:cNvSpPr txBox="1"/>
          <p:nvPr/>
        </p:nvSpPr>
        <p:spPr>
          <a:xfrm>
            <a:off x="1437873" y="931157"/>
            <a:ext cx="248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NA polymerase activit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882C055-A642-8D19-A741-BD23A35BBF55}"/>
              </a:ext>
            </a:extLst>
          </p:cNvPr>
          <p:cNvSpPr txBox="1"/>
          <p:nvPr/>
        </p:nvSpPr>
        <p:spPr>
          <a:xfrm>
            <a:off x="7341042" y="713339"/>
            <a:ext cx="248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NA ligase activity</a:t>
            </a:r>
          </a:p>
        </p:txBody>
      </p:sp>
    </p:spTree>
    <p:extLst>
      <p:ext uri="{BB962C8B-B14F-4D97-AF65-F5344CB8AC3E}">
        <p14:creationId xmlns:p14="http://schemas.microsoft.com/office/powerpoint/2010/main" val="438658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oxo">
      <a:dk1>
        <a:sysClr val="windowText" lastClr="000000"/>
      </a:dk1>
      <a:lt1>
        <a:sysClr val="window" lastClr="FFFFFF"/>
      </a:lt1>
      <a:dk2>
        <a:srgbClr val="373545"/>
      </a:dk2>
      <a:lt2>
        <a:srgbClr val="DCD8DC"/>
      </a:lt2>
      <a:accent1>
        <a:srgbClr val="AD84C6"/>
      </a:accent1>
      <a:accent2>
        <a:srgbClr val="8784C7"/>
      </a:accent2>
      <a:accent3>
        <a:srgbClr val="5D739A"/>
      </a:accent3>
      <a:accent4>
        <a:srgbClr val="6997AF"/>
      </a:accent4>
      <a:accent5>
        <a:srgbClr val="84ACB6"/>
      </a:accent5>
      <a:accent6>
        <a:srgbClr val="6F8183"/>
      </a:accent6>
      <a:hlink>
        <a:srgbClr val="69A020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4</TotalTime>
  <Words>132</Words>
  <Application>Microsoft Office PowerPoint</Application>
  <PresentationFormat>Widescreen</PresentationFormat>
  <Paragraphs>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a Sofia da Silva Correia</dc:creator>
  <cp:lastModifiedBy>Chakraborty, Anirban</cp:lastModifiedBy>
  <cp:revision>150</cp:revision>
  <cp:lastPrinted>2023-08-29T23:30:28Z</cp:lastPrinted>
  <dcterms:created xsi:type="dcterms:W3CDTF">2021-02-24T12:59:59Z</dcterms:created>
  <dcterms:modified xsi:type="dcterms:W3CDTF">2023-09-19T17:05:13Z</dcterms:modified>
</cp:coreProperties>
</file>